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2"/>
    <p:sldId id="259" r:id="rId3"/>
    <p:sldId id="258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</p:sldIdLst>
  <p:sldSz cx="12192000" cy="6858000"/>
  <p:notesSz cx="6858000" cy="9144000"/>
  <p:custDataLst>
    <p:tags r:id="rId1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 varScale="1">
        <p:scale>
          <a:sx n="85" d="100"/>
          <a:sy n="85" d="100"/>
        </p:scale>
        <p:origin x="5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9FAAD-400B-4630-BF60-747E807474BC}" type="datetimeFigureOut">
              <a:rPr lang="zh-CN" altLang="en-US" smtClean="0"/>
              <a:t>2023/8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F6759-CE0E-4855-A6CF-AEA29828D7A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8024" y="0"/>
            <a:ext cx="5247501" cy="300105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5836" y="0"/>
            <a:ext cx="5096767" cy="300105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4637" y="3429000"/>
            <a:ext cx="5318448" cy="2735277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34923" y="3329040"/>
            <a:ext cx="5096766" cy="2835237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11020" y="6307494"/>
            <a:ext cx="11663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1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ALM on PE </a:t>
            </a:r>
            <a:endParaRPr lang="zh-CN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534" y="144481"/>
            <a:ext cx="5361992" cy="296713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8749" y="144481"/>
            <a:ext cx="5206483" cy="296713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1092" y="3287486"/>
            <a:ext cx="5349551" cy="296713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277" y="3331121"/>
            <a:ext cx="5106956" cy="29235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46922" y="6388359"/>
            <a:ext cx="111283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0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UWP on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thma</a:t>
            </a:r>
            <a:endParaRPr lang="en-US" altLang="zh-CN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6475" y="82277"/>
            <a:ext cx="5226610" cy="295950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5130" y="82276"/>
            <a:ext cx="5226610" cy="295950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3" y="3225663"/>
            <a:ext cx="5349551" cy="295950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98435" y="3374952"/>
            <a:ext cx="5040000" cy="2959503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528735" y="6334455"/>
            <a:ext cx="10674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1. Forest plot (A), leave-one-out analysis (B), scatter plot (C) and funnel plot (D) of the effect of UWP on COPD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6" y="144481"/>
            <a:ext cx="5218924" cy="295950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2690" y="144784"/>
            <a:ext cx="5139000" cy="29592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7076" y="3287486"/>
            <a:ext cx="5218924" cy="29592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277" y="3373578"/>
            <a:ext cx="5063413" cy="295920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597159" y="6332778"/>
            <a:ext cx="102823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2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UWP on PE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6" y="62816"/>
            <a:ext cx="5131840" cy="2959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3543" y="62816"/>
            <a:ext cx="5226571" cy="29592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4" y="3378293"/>
            <a:ext cx="5175382" cy="29592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5835" y="3378293"/>
            <a:ext cx="5119397" cy="29592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42122" y="6388017"/>
            <a:ext cx="10612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2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HGS(R) on IRTI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534" y="76058"/>
            <a:ext cx="5218924" cy="314300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5368" y="76058"/>
            <a:ext cx="5040000" cy="3143004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6618" y="3287485"/>
            <a:ext cx="5309382" cy="3046663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55368" y="3429000"/>
            <a:ext cx="5040000" cy="2959474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516293" y="6463004"/>
            <a:ext cx="10506269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3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HGS(R) on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thma</a:t>
            </a:r>
            <a:endParaRPr lang="en-US" altLang="zh-CN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7" y="144481"/>
            <a:ext cx="5218923" cy="2959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7411" y="144481"/>
            <a:ext cx="5144279" cy="29592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4" y="3334700"/>
            <a:ext cx="5262466" cy="29592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5836" y="3334700"/>
            <a:ext cx="5075854" cy="29592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460310" y="6363478"/>
            <a:ext cx="10307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4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HGS(L) on CB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7" y="144481"/>
            <a:ext cx="5131839" cy="2959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0956" y="187167"/>
            <a:ext cx="5170733" cy="29592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7076" y="3429000"/>
            <a:ext cx="5218923" cy="29592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8277" y="3429000"/>
            <a:ext cx="5063412" cy="29592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16767" y="6431902"/>
            <a:ext cx="115388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5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HGS(L) on IRTI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533" y="144482"/>
            <a:ext cx="5349551" cy="295328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1745" y="144481"/>
            <a:ext cx="5139945" cy="302872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2" y="3287487"/>
            <a:ext cx="5262467" cy="295328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91690" y="3287486"/>
            <a:ext cx="5040000" cy="2953283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60310" y="6351037"/>
            <a:ext cx="10792408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6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HGS(L) on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thma</a:t>
            </a:r>
            <a:endParaRPr lang="en-US" altLang="zh-CN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7" y="144481"/>
            <a:ext cx="5306008" cy="295950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3847" y="144481"/>
            <a:ext cx="5040000" cy="303686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4" y="3287486"/>
            <a:ext cx="5361992" cy="295950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5836" y="3429000"/>
            <a:ext cx="5040000" cy="2959503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416767" y="6373969"/>
            <a:ext cx="114579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7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LHGS on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rc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6" y="93307"/>
            <a:ext cx="5131839" cy="29592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8277" y="144481"/>
            <a:ext cx="5063413" cy="29592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4" y="3361009"/>
            <a:ext cx="5262466" cy="29592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5836" y="3361009"/>
            <a:ext cx="5075854" cy="295920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416767" y="6506547"/>
            <a:ext cx="103383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8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LHGS on </a:t>
            </a:r>
            <a:r>
              <a:rPr lang="en-US" altLang="zh-CN" sz="16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neu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0310" y="144481"/>
            <a:ext cx="3732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183085" y="211494"/>
            <a:ext cx="4851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16767" y="3570514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195526" y="3528960"/>
            <a:ext cx="460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077" y="144481"/>
            <a:ext cx="5218923" cy="2959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6468" y="144481"/>
            <a:ext cx="5033254" cy="29592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534" y="3359632"/>
            <a:ext cx="5262466" cy="29592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6468" y="3359632"/>
            <a:ext cx="5033254" cy="29592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60310" y="6388359"/>
            <a:ext cx="113522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9. </a:t>
            </a:r>
            <a:r>
              <a:rPr lang="en-US" altLang="zh-CN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est plot (A), leave-one-out analysis (B), scatter plot (C) and funnel plot (D) of the effect of UWP on IRTI 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c92c4acf-1ac1-41d5-b9f6-720943587d57"/>
  <p:tag name="COMMONDATA" val="eyJoZGlkIjoiN2ExMmQxNzgzMWQzMWFlMDgxOGE3OTYyMWY0NjA5OWE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435</Words>
  <Application>Microsoft Office PowerPoint</Application>
  <PresentationFormat>宽屏</PresentationFormat>
  <Paragraphs>60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梓甜</dc:creator>
  <cp:lastModifiedBy>悦 苏</cp:lastModifiedBy>
  <cp:revision>5</cp:revision>
  <dcterms:created xsi:type="dcterms:W3CDTF">2023-07-05T12:47:00Z</dcterms:created>
  <dcterms:modified xsi:type="dcterms:W3CDTF">2023-08-20T15:00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1D0CC6096C8456EBC0B35A84C13CE21_12</vt:lpwstr>
  </property>
  <property fmtid="{D5CDD505-2E9C-101B-9397-08002B2CF9AE}" pid="3" name="KSOProductBuildVer">
    <vt:lpwstr>2052-11.1.0.14309</vt:lpwstr>
  </property>
</Properties>
</file>